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4"/>
  </p:notesMasterIdLst>
  <p:sldIdLst>
    <p:sldId id="256" r:id="rId2"/>
    <p:sldId id="257" r:id="rId3"/>
    <p:sldId id="258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59" r:id="rId27"/>
    <p:sldId id="282" r:id="rId28"/>
    <p:sldId id="283" r:id="rId29"/>
    <p:sldId id="284" r:id="rId30"/>
    <p:sldId id="285" r:id="rId31"/>
    <p:sldId id="287" r:id="rId32"/>
    <p:sldId id="288" r:id="rId33"/>
    <p:sldId id="289" r:id="rId34"/>
    <p:sldId id="290" r:id="rId35"/>
    <p:sldId id="291" r:id="rId36"/>
    <p:sldId id="292" r:id="rId37"/>
    <p:sldId id="293" r:id="rId38"/>
    <p:sldId id="294" r:id="rId39"/>
    <p:sldId id="295" r:id="rId40"/>
    <p:sldId id="297" r:id="rId41"/>
    <p:sldId id="298" r:id="rId42"/>
    <p:sldId id="299" r:id="rId43"/>
    <p:sldId id="300" r:id="rId44"/>
    <p:sldId id="301" r:id="rId45"/>
    <p:sldId id="302" r:id="rId46"/>
    <p:sldId id="303" r:id="rId47"/>
    <p:sldId id="304" r:id="rId48"/>
    <p:sldId id="305" r:id="rId49"/>
    <p:sldId id="306" r:id="rId50"/>
    <p:sldId id="307" r:id="rId51"/>
    <p:sldId id="308" r:id="rId52"/>
    <p:sldId id="309" r:id="rId5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03" autoAdjust="0"/>
  </p:normalViewPr>
  <p:slideViewPr>
    <p:cSldViewPr>
      <p:cViewPr>
        <p:scale>
          <a:sx n="100" d="100"/>
          <a:sy n="100" d="100"/>
        </p:scale>
        <p:origin x="-210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viewProps" Target="view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07107C-8342-477E-97E5-E45643267D49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760297-7EE8-4024-A3D9-CC2299575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8001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760297-7EE8-4024-A3D9-CC229957510B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7780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370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8696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830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2397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9318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4824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6687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712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335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1723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3695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DD8AE-65F0-49FA-9863-217021F0AB98}" type="datetimeFigureOut">
              <a:rPr lang="en-GB" smtClean="0"/>
              <a:t>09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A6F57-3B73-420C-8118-778ABC1B8A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6427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 smtClean="0"/>
              <a:t>IGV Peaks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6834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9</a:t>
            </a:r>
            <a:endParaRPr lang="en-GB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78" r="1503" b="17956"/>
          <a:stretch/>
        </p:blipFill>
        <p:spPr bwMode="auto">
          <a:xfrm>
            <a:off x="324000" y="1340768"/>
            <a:ext cx="8496000" cy="347000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38" t="62773" r="67867" b="27591"/>
          <a:stretch/>
        </p:blipFill>
        <p:spPr bwMode="auto">
          <a:xfrm>
            <a:off x="4389115" y="3769990"/>
            <a:ext cx="542925" cy="5194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38" t="62773" r="71014" b="27591"/>
          <a:stretch/>
        </p:blipFill>
        <p:spPr bwMode="auto">
          <a:xfrm>
            <a:off x="2804940" y="3769990"/>
            <a:ext cx="271462" cy="5194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186218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6538" y="181229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1</a:t>
            </a:r>
            <a:r>
              <a:rPr lang="en-GB" sz="1400" dirty="0" smtClean="0"/>
              <a:t>0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48098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44550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09273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16063" y="308484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1</a:t>
            </a:r>
            <a:r>
              <a:rPr lang="en-GB" sz="1400" dirty="0" smtClean="0"/>
              <a:t>0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3722365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35113" y="374211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25</a:t>
            </a:r>
            <a:r>
              <a:rPr lang="en-GB" sz="1400" dirty="0" smtClean="0"/>
              <a:t> -25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3491880" y="453906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177</a:t>
            </a:r>
            <a:endParaRPr lang="en-GB" dirty="0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2863999" y="4582502"/>
            <a:ext cx="194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5309150" y="4582502"/>
            <a:ext cx="1224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710730" y="4054063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508104" y="453906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178</a:t>
            </a:r>
            <a:endParaRPr lang="en-GB" dirty="0"/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6660368" y="4581128"/>
            <a:ext cx="1224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859322" y="4537695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17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613998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0</a:t>
            </a:r>
            <a:endParaRPr lang="en-GB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64" r="1289" b="18068"/>
          <a:stretch/>
        </p:blipFill>
        <p:spPr bwMode="auto">
          <a:xfrm>
            <a:off x="324000" y="1724025"/>
            <a:ext cx="8496000" cy="347875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6" t="64411" r="62260" b="27975"/>
          <a:stretch/>
        </p:blipFill>
        <p:spPr bwMode="auto">
          <a:xfrm>
            <a:off x="4667250" y="4258419"/>
            <a:ext cx="1047750" cy="409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6" t="64397" r="66543" b="27975"/>
          <a:stretch/>
        </p:blipFill>
        <p:spPr bwMode="auto">
          <a:xfrm>
            <a:off x="3131840" y="4258420"/>
            <a:ext cx="679140" cy="4103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373885" y="4931876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292</a:t>
            </a:r>
            <a:endParaRPr lang="en-GB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3746004" y="4975309"/>
            <a:ext cx="194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5868280" y="4975309"/>
            <a:ext cx="208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516216" y="4931876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293</a:t>
            </a:r>
            <a:endParaRPr lang="en-GB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25475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6538" y="220486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87356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06538" y="283807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48531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16063" y="347742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</a:t>
            </a:r>
            <a:endParaRPr lang="en-GB" sz="1400" dirty="0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114939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735113" y="413468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-10</a:t>
            </a:r>
            <a:endParaRPr lang="en-GB" sz="1400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710730" y="4446637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5646736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1</a:t>
            </a:r>
            <a:endParaRPr lang="en-GB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34" r="1338" b="18281"/>
          <a:stretch/>
        </p:blipFill>
        <p:spPr bwMode="auto">
          <a:xfrm>
            <a:off x="324000" y="2009775"/>
            <a:ext cx="8496000" cy="349208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83" t="62495" r="52438" b="27893"/>
          <a:stretch/>
        </p:blipFill>
        <p:spPr bwMode="auto">
          <a:xfrm>
            <a:off x="2708522" y="4471020"/>
            <a:ext cx="2314576" cy="5173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842395" y="5238958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597</a:t>
            </a:r>
            <a:endParaRPr lang="en-GB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3746004" y="5291916"/>
            <a:ext cx="72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5758268" y="5291916"/>
            <a:ext cx="208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516216" y="5238958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598</a:t>
            </a:r>
            <a:endParaRPr lang="en-GB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57136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6538" y="252147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19016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06538" y="315468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80191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16063" y="379402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441071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735113" y="438461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-10</a:t>
            </a:r>
            <a:endParaRPr lang="en-GB" sz="1400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710730" y="4763244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806240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2</a:t>
            </a:r>
            <a:endParaRPr lang="en-GB" dirty="0"/>
          </a:p>
        </p:txBody>
      </p:sp>
      <p:pic>
        <p:nvPicPr>
          <p:cNvPr id="9219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87" r="1625" b="16034"/>
          <a:stretch/>
        </p:blipFill>
        <p:spPr bwMode="auto">
          <a:xfrm>
            <a:off x="324000" y="1484784"/>
            <a:ext cx="8496000" cy="36045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07" t="63794" r="73201" b="27559"/>
          <a:stretch/>
        </p:blipFill>
        <p:spPr bwMode="auto">
          <a:xfrm>
            <a:off x="4778499" y="4005064"/>
            <a:ext cx="733425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23" t="65221" r="49048" b="28441"/>
          <a:stretch/>
        </p:blipFill>
        <p:spPr bwMode="auto">
          <a:xfrm>
            <a:off x="1907704" y="4076700"/>
            <a:ext cx="1600200" cy="3421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3491880" y="4763477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738</a:t>
            </a:r>
            <a:endParaRPr lang="en-GB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2148111" y="4816435"/>
            <a:ext cx="320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6224224" y="4816435"/>
            <a:ext cx="208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982172" y="4763477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740</a:t>
            </a:r>
            <a:endParaRPr lang="en-GB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03873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06538" y="198884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65753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706538" y="262205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26928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1716063" y="326139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3908440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1735113" y="385198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20 -20</a:t>
            </a:r>
            <a:endParaRPr lang="en-GB" sz="1400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1710730" y="4230613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681434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3</a:t>
            </a:r>
            <a:endParaRPr lang="en-GB" dirty="0"/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15" r="1489" b="17358"/>
          <a:stretch/>
        </p:blipFill>
        <p:spPr bwMode="auto">
          <a:xfrm>
            <a:off x="324000" y="1556792"/>
            <a:ext cx="8496000" cy="349978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60998" y="4725144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885</a:t>
            </a:r>
            <a:endParaRPr lang="en-GB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016072" y="4778102"/>
            <a:ext cx="309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5364320" y="4778102"/>
            <a:ext cx="3276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751290" y="4725144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886</a:t>
            </a:r>
            <a:endParaRPr lang="en-GB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07264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02274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69144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6538" y="265596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30319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16063" y="329530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3942348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35113" y="388589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20 -20</a:t>
            </a:r>
            <a:endParaRPr lang="en-GB" sz="1400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710730" y="4264521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476908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4</a:t>
            </a:r>
            <a:endParaRPr lang="en-GB" dirty="0"/>
          </a:p>
        </p:txBody>
      </p:sp>
      <p:pic>
        <p:nvPicPr>
          <p:cNvPr id="1126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97" r="1441" b="17922"/>
          <a:stretch/>
        </p:blipFill>
        <p:spPr bwMode="auto">
          <a:xfrm>
            <a:off x="324000" y="1752601"/>
            <a:ext cx="8496000" cy="350099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355976" y="495625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919</a:t>
            </a:r>
            <a:endParaRPr lang="en-GB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4356048" y="5009217"/>
            <a:ext cx="64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5758316" y="5009217"/>
            <a:ext cx="252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751290" y="495625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920</a:t>
            </a:r>
            <a:endParaRPr lang="en-GB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30375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25386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92255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6538" y="288707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53430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16063" y="352641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173463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35113" y="411700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20 -20</a:t>
            </a:r>
            <a:endParaRPr lang="en-GB" sz="1400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710730" y="4495636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585808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5</a:t>
            </a:r>
            <a:endParaRPr lang="en-GB" dirty="0"/>
          </a:p>
        </p:txBody>
      </p:sp>
      <p:pic>
        <p:nvPicPr>
          <p:cNvPr id="1229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32" r="1455" b="17781"/>
          <a:stretch/>
        </p:blipFill>
        <p:spPr bwMode="auto">
          <a:xfrm>
            <a:off x="324000" y="1571625"/>
            <a:ext cx="8496000" cy="35287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03848" y="479181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986</a:t>
            </a:r>
            <a:endParaRPr lang="en-GB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2087864" y="4844777"/>
            <a:ext cx="2988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6660232" y="4844777"/>
            <a:ext cx="14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751290" y="479181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988</a:t>
            </a:r>
            <a:endParaRPr lang="en-GB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13931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08942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75811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6538" y="272263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36986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16063" y="336197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009023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35113" y="395256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200</a:t>
            </a:r>
            <a:endParaRPr lang="en-GB" sz="1400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710730" y="4427587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517789" y="4850110"/>
            <a:ext cx="1008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652120" y="479715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98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5091767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6</a:t>
            </a:r>
            <a:endParaRPr lang="en-GB" dirty="0"/>
          </a:p>
        </p:txBody>
      </p:sp>
      <p:pic>
        <p:nvPicPr>
          <p:cNvPr id="1331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44" r="1486" b="18425"/>
          <a:stretch/>
        </p:blipFill>
        <p:spPr bwMode="auto">
          <a:xfrm>
            <a:off x="324000" y="1990725"/>
            <a:ext cx="8496000" cy="34675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71" t="62658" r="44337" b="27707"/>
          <a:stretch/>
        </p:blipFill>
        <p:spPr bwMode="auto">
          <a:xfrm>
            <a:off x="3790950" y="4437112"/>
            <a:ext cx="1543050" cy="519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4499992" y="5186000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999</a:t>
            </a:r>
            <a:endParaRPr lang="en-GB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4608048" y="5238958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53349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6538" y="248360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15230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06538" y="311681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76405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16063" y="375616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403204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735113" y="434674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-10</a:t>
            </a:r>
            <a:endParaRPr lang="en-GB" sz="1400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710730" y="4734669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5695553" y="5244291"/>
            <a:ext cx="118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896559" y="5191333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00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946442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7</a:t>
            </a:r>
            <a:endParaRPr lang="en-GB" dirty="0"/>
          </a:p>
        </p:txBody>
      </p:sp>
      <p:pic>
        <p:nvPicPr>
          <p:cNvPr id="1433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84" r="1613" b="17804"/>
          <a:stretch/>
        </p:blipFill>
        <p:spPr bwMode="auto">
          <a:xfrm>
            <a:off x="324000" y="1700808"/>
            <a:ext cx="8496000" cy="350334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38" t="62894" r="69559" b="27455"/>
          <a:stretch/>
        </p:blipFill>
        <p:spPr bwMode="auto">
          <a:xfrm>
            <a:off x="4706491" y="4158605"/>
            <a:ext cx="742950" cy="520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39" t="62894" r="69559" b="27455"/>
          <a:stretch/>
        </p:blipFill>
        <p:spPr bwMode="auto">
          <a:xfrm>
            <a:off x="2195736" y="4158605"/>
            <a:ext cx="371475" cy="520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131840" y="4888210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183</a:t>
            </a:r>
            <a:endParaRPr lang="en-GB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070770" y="4941168"/>
            <a:ext cx="291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23570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18581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85451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6538" y="281902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47578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16063" y="345837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00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105414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35113" y="404895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40 -40</a:t>
            </a:r>
            <a:endParaRPr lang="en-GB" sz="1400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710730" y="4436879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570915" y="4946501"/>
            <a:ext cx="3024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660232" y="4893543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18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2205544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 smtClean="0"/>
              <a:t>Peak 18</a:t>
            </a:r>
            <a:br>
              <a:rPr lang="en-GB" dirty="0" smtClean="0"/>
            </a:br>
            <a:r>
              <a:rPr lang="en-GB" sz="1300" dirty="0" smtClean="0"/>
              <a:t>msmeg_2332 and msmeg_2334 not on microarray</a:t>
            </a:r>
            <a:endParaRPr lang="en-GB" sz="1300" dirty="0"/>
          </a:p>
        </p:txBody>
      </p:sp>
      <p:pic>
        <p:nvPicPr>
          <p:cNvPr id="1536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09" r="1308" b="18388"/>
          <a:stretch/>
        </p:blipFill>
        <p:spPr bwMode="auto">
          <a:xfrm>
            <a:off x="324000" y="1952625"/>
            <a:ext cx="8496000" cy="34651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39" t="62894" r="69559" b="27455"/>
          <a:stretch/>
        </p:blipFill>
        <p:spPr bwMode="auto">
          <a:xfrm>
            <a:off x="2195736" y="4422487"/>
            <a:ext cx="371475" cy="520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131840" y="515209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332</a:t>
            </a:r>
            <a:endParaRPr lang="en-GB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195736" y="5205050"/>
            <a:ext cx="291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49958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44969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0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11839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6538" y="308291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0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73966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16063" y="372225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00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369296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35113" y="431284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40 -40</a:t>
            </a:r>
            <a:endParaRPr lang="en-GB" sz="1400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710730" y="4700761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181972" y="5210383"/>
            <a:ext cx="468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076056" y="5157425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33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73411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</a:t>
            </a:r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16" r="1227" b="10359"/>
          <a:stretch/>
        </p:blipFill>
        <p:spPr bwMode="auto">
          <a:xfrm>
            <a:off x="324000" y="1321717"/>
            <a:ext cx="8496000" cy="38935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>
            <a:off x="1725924" y="4941168"/>
            <a:ext cx="3024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5181972" y="4941168"/>
            <a:ext cx="3420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6159099" y="4883015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427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2915816" y="4883015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426</a:t>
            </a:r>
            <a:endParaRPr lang="en-GB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0712" y="188519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658913" y="183529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10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5588" y="248337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658913" y="241136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100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5588" y="311090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658913" y="304921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100000</a:t>
            </a:r>
            <a:endParaRPr lang="en-GB" sz="1400" dirty="0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5588" y="372087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658913" y="368776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100</a:t>
            </a:r>
            <a:endParaRPr lang="en-GB" sz="14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1728472" y="4255273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33442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19</a:t>
            </a:r>
            <a:endParaRPr lang="en-GB" dirty="0"/>
          </a:p>
        </p:txBody>
      </p:sp>
      <p:pic>
        <p:nvPicPr>
          <p:cNvPr id="1638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47" r="1256" b="17749"/>
          <a:stretch/>
        </p:blipFill>
        <p:spPr bwMode="auto">
          <a:xfrm>
            <a:off x="324000" y="1844824"/>
            <a:ext cx="8496000" cy="349023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5724128" y="5041984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425</a:t>
            </a:r>
            <a:endParaRPr lang="en-GB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4339346" y="5094942"/>
            <a:ext cx="367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38948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06538" y="233958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00828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6538" y="297280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62955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16063" y="361214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50000</a:t>
            </a:r>
            <a:endParaRPr lang="en-GB" sz="1400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259188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35113" y="420273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40 -100</a:t>
            </a:r>
            <a:endParaRPr lang="en-GB" sz="1400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710730" y="4696569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8159049" y="5100275"/>
            <a:ext cx="46726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8143515" y="5047317"/>
            <a:ext cx="964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426</a:t>
            </a:r>
            <a:endParaRPr lang="en-GB" dirty="0"/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1763688" y="5094709"/>
            <a:ext cx="187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2339752" y="5041751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42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0684079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0</a:t>
            </a:r>
            <a:endParaRPr lang="en-GB" dirty="0"/>
          </a:p>
        </p:txBody>
      </p:sp>
      <p:pic>
        <p:nvPicPr>
          <p:cNvPr id="1741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09" r="1348" b="18080"/>
          <a:stretch/>
        </p:blipFill>
        <p:spPr bwMode="auto">
          <a:xfrm>
            <a:off x="324000" y="1674137"/>
            <a:ext cx="8496000" cy="348305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73" t="63792" r="64499" b="27144"/>
          <a:stretch/>
        </p:blipFill>
        <p:spPr bwMode="auto">
          <a:xfrm>
            <a:off x="4584179" y="4182988"/>
            <a:ext cx="923925" cy="4878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37" t="63792" r="64499" b="27144"/>
          <a:stretch/>
        </p:blipFill>
        <p:spPr bwMode="auto">
          <a:xfrm>
            <a:off x="2660352" y="4177655"/>
            <a:ext cx="461963" cy="4878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5638403" y="487335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08</a:t>
            </a:r>
            <a:endParaRPr lang="en-GB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6309717" y="4926310"/>
            <a:ext cx="198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22084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17095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83965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6538" y="280417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46092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16063" y="344351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090556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35113" y="403410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-10</a:t>
            </a:r>
            <a:endParaRPr lang="en-GB" sz="1400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710730" y="4408537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722816" y="4922118"/>
            <a:ext cx="46726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2843808" y="4926077"/>
            <a:ext cx="223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635896" y="487311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06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6804248" y="4869160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0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4992954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1</a:t>
            </a:r>
            <a:endParaRPr lang="en-GB" dirty="0"/>
          </a:p>
        </p:txBody>
      </p:sp>
      <p:pic>
        <p:nvPicPr>
          <p:cNvPr id="1843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835" r="1357" b="18216"/>
          <a:stretch/>
        </p:blipFill>
        <p:spPr bwMode="auto">
          <a:xfrm>
            <a:off x="324000" y="1772816"/>
            <a:ext cx="8496000" cy="344241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638403" y="4946734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22</a:t>
            </a:r>
            <a:endParaRPr lang="en-GB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7884368" y="4999692"/>
            <a:ext cx="90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28470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6538" y="224433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45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90350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87755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45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53430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16063" y="351689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45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163938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35113" y="410748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200</a:t>
            </a:r>
            <a:endParaRPr lang="en-GB" sz="1400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710730" y="4567644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4589278" y="5005025"/>
            <a:ext cx="291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1979960" y="4999459"/>
            <a:ext cx="22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915816" y="4946501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21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8100392" y="494254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2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6849083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2</a:t>
            </a:r>
            <a:endParaRPr lang="en-GB" dirty="0"/>
          </a:p>
        </p:txBody>
      </p:sp>
      <p:pic>
        <p:nvPicPr>
          <p:cNvPr id="1945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26" r="1484" b="17630"/>
          <a:stretch/>
        </p:blipFill>
        <p:spPr bwMode="auto">
          <a:xfrm>
            <a:off x="324000" y="1638299"/>
            <a:ext cx="8496000" cy="35166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719936" y="4842543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26</a:t>
            </a:r>
            <a:endParaRPr lang="en-GB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6003" y="2180427"/>
            <a:ext cx="1582103" cy="4081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788071" y="214322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0</a:t>
            </a:r>
            <a:endParaRPr lang="en-GB" sz="14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0879" y="2799231"/>
            <a:ext cx="1582103" cy="4081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88071" y="277643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0879" y="3430031"/>
            <a:ext cx="1582103" cy="4081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97596" y="341578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8549" y="4063813"/>
            <a:ext cx="1227974" cy="31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816646" y="400636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800</a:t>
            </a:r>
            <a:endParaRPr lang="en-GB" sz="1400" dirty="0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4924935" y="4919300"/>
            <a:ext cx="291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1907952" y="4913734"/>
            <a:ext cx="22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997349" y="4842310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2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493837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3</a:t>
            </a:r>
            <a:endParaRPr lang="en-GB" dirty="0"/>
          </a:p>
        </p:txBody>
      </p:sp>
      <p:pic>
        <p:nvPicPr>
          <p:cNvPr id="2048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80" r="1511" b="17647"/>
          <a:stretch/>
        </p:blipFill>
        <p:spPr bwMode="auto">
          <a:xfrm>
            <a:off x="324000" y="1700808"/>
            <a:ext cx="8496000" cy="353538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92" t="63674" r="75379" b="26987"/>
          <a:stretch/>
        </p:blipFill>
        <p:spPr bwMode="auto">
          <a:xfrm>
            <a:off x="5498951" y="4230613"/>
            <a:ext cx="666750" cy="5035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56" t="63674" r="75379" b="26987"/>
          <a:stretch/>
        </p:blipFill>
        <p:spPr bwMode="auto">
          <a:xfrm>
            <a:off x="1826171" y="4230613"/>
            <a:ext cx="333375" cy="5035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6948264" y="4941401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71</a:t>
            </a:r>
            <a:endParaRPr lang="en-GB" dirty="0"/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27937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1706538" y="223900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00000</a:t>
            </a:r>
            <a:endParaRPr lang="en-GB" sz="1400" dirty="0"/>
          </a:p>
        </p:txBody>
      </p:sp>
      <p:pic>
        <p:nvPicPr>
          <p:cNvPr id="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89817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1706538" y="287221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00000</a:t>
            </a:r>
            <a:endParaRPr lang="en-GB" sz="1400" dirty="0"/>
          </a:p>
        </p:txBody>
      </p:sp>
      <p:pic>
        <p:nvPicPr>
          <p:cNvPr id="2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52897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1716063" y="351156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00000</a:t>
            </a:r>
            <a:endParaRPr lang="en-GB" sz="1400" dirty="0"/>
          </a:p>
        </p:txBody>
      </p:sp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149080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1735113" y="409262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100</a:t>
            </a:r>
            <a:endParaRPr lang="en-GB" sz="1400" dirty="0"/>
          </a:p>
        </p:txBody>
      </p:sp>
      <p:cxnSp>
        <p:nvCxnSpPr>
          <p:cNvPr id="32" name="Straight Connector 31"/>
          <p:cNvCxnSpPr/>
          <p:nvPr/>
        </p:nvCxnSpPr>
        <p:spPr>
          <a:xfrm>
            <a:off x="1710730" y="4467061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6885869" y="4999692"/>
            <a:ext cx="75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1979960" y="4994126"/>
            <a:ext cx="381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3563888" y="4941168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7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6868312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4</a:t>
            </a:r>
            <a:endParaRPr lang="en-GB" dirty="0"/>
          </a:p>
        </p:txBody>
      </p:sp>
      <p:pic>
        <p:nvPicPr>
          <p:cNvPr id="21507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68" r="1491" b="17739"/>
          <a:stretch/>
        </p:blipFill>
        <p:spPr bwMode="auto">
          <a:xfrm>
            <a:off x="324000" y="1844824"/>
            <a:ext cx="8496000" cy="348179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71" t="62430" r="67864" b="27655"/>
          <a:stretch/>
        </p:blipFill>
        <p:spPr bwMode="auto">
          <a:xfrm>
            <a:off x="5410175" y="4254996"/>
            <a:ext cx="971550" cy="5344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35" t="62430" r="67864" b="27655"/>
          <a:stretch/>
        </p:blipFill>
        <p:spPr bwMode="auto">
          <a:xfrm>
            <a:off x="2195736" y="4253156"/>
            <a:ext cx="595139" cy="5344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6738714" y="5032226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983</a:t>
            </a:r>
            <a:endParaRPr lang="en-GB" dirty="0"/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237019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1706538" y="232983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00000</a:t>
            </a:r>
            <a:endParaRPr lang="en-GB" sz="1400" dirty="0"/>
          </a:p>
        </p:txBody>
      </p:sp>
      <p:pic>
        <p:nvPicPr>
          <p:cNvPr id="2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98900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1706538" y="296304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00000</a:t>
            </a:r>
            <a:endParaRPr lang="en-GB" sz="1400" dirty="0"/>
          </a:p>
        </p:txBody>
      </p:sp>
      <p:pic>
        <p:nvPicPr>
          <p:cNvPr id="2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61980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1716063" y="360238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00000</a:t>
            </a:r>
            <a:endParaRPr lang="en-GB" sz="1400" dirty="0"/>
          </a:p>
        </p:txBody>
      </p:sp>
      <p:pic>
        <p:nvPicPr>
          <p:cNvPr id="3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4239905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1735113" y="418345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600</a:t>
            </a:r>
            <a:endParaRPr lang="en-GB" sz="1400" dirty="0"/>
          </a:p>
        </p:txBody>
      </p:sp>
      <p:cxnSp>
        <p:nvCxnSpPr>
          <p:cNvPr id="33" name="Straight Connector 32"/>
          <p:cNvCxnSpPr/>
          <p:nvPr/>
        </p:nvCxnSpPr>
        <p:spPr>
          <a:xfrm>
            <a:off x="1710730" y="4757911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6463258" y="5090517"/>
            <a:ext cx="115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>
            <a:off x="2268168" y="5084951"/>
            <a:ext cx="345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563888" y="5031993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928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8581981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5</a:t>
            </a:r>
            <a:endParaRPr lang="en-GB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97" r="1656" b="10390"/>
          <a:stretch/>
        </p:blipFill>
        <p:spPr bwMode="auto">
          <a:xfrm>
            <a:off x="467543" y="1628800"/>
            <a:ext cx="8344800" cy="38349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847106" y="216220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803882" y="210279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25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841982" y="276038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803882" y="270743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25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841982" y="338646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803882" y="333724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25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841982" y="400506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803882" y="396626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-1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879129" y="5206053"/>
            <a:ext cx="345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275856" y="5147900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131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6283402" y="5205820"/>
            <a:ext cx="216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948264" y="514766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132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845058" y="4517324"/>
            <a:ext cx="69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927872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6</a:t>
            </a:r>
            <a:endParaRPr lang="en-GB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39" r="1406" b="17716"/>
          <a:stretch/>
        </p:blipFill>
        <p:spPr bwMode="auto">
          <a:xfrm>
            <a:off x="324000" y="1772816"/>
            <a:ext cx="8496000" cy="348161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29669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691680" y="225633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91392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91680" y="286097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54000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691680" y="349078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15860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691680" y="411981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-1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4346451" y="5013176"/>
            <a:ext cx="90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490467" y="4975076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161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508104" y="5013176"/>
            <a:ext cx="3024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732856" y="4490070"/>
            <a:ext cx="69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588224" y="4969743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16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6183312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7</a:t>
            </a:r>
            <a:endParaRPr lang="en-GB" dirty="0"/>
          </a:p>
        </p:txBody>
      </p:sp>
      <p:pic>
        <p:nvPicPr>
          <p:cNvPr id="2355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90" r="1544" b="18000"/>
          <a:stretch/>
        </p:blipFill>
        <p:spPr bwMode="auto">
          <a:xfrm>
            <a:off x="324000" y="1772816"/>
            <a:ext cx="8496000" cy="35008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35" t="65811" r="74062" b="26094"/>
          <a:stretch/>
        </p:blipFill>
        <p:spPr bwMode="auto">
          <a:xfrm>
            <a:off x="3440435" y="4404040"/>
            <a:ext cx="828675" cy="4365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44" t="65811" r="74062" b="26094"/>
          <a:stretch/>
        </p:blipFill>
        <p:spPr bwMode="auto">
          <a:xfrm>
            <a:off x="1752600" y="4403204"/>
            <a:ext cx="551731" cy="4365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32676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91680" y="228639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94399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691680" y="289103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57007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691680" y="352085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18867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691680" y="414987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25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7884368" y="5043241"/>
            <a:ext cx="90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411760" y="5005141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398</a:t>
            </a:r>
            <a:endParaRPr lang="en-GB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5460479" y="5043241"/>
            <a:ext cx="3024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691680" y="4778102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156176" y="499980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400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8239075" y="5003651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401</a:t>
            </a:r>
            <a:endParaRPr lang="en-GB" dirty="0"/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1816982" y="5041751"/>
            <a:ext cx="176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063439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8</a:t>
            </a:r>
            <a:endParaRPr lang="en-GB" dirty="0"/>
          </a:p>
        </p:txBody>
      </p:sp>
      <p:pic>
        <p:nvPicPr>
          <p:cNvPr id="2457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06" r="1367" b="17766"/>
          <a:stretch/>
        </p:blipFill>
        <p:spPr bwMode="auto">
          <a:xfrm>
            <a:off x="324000" y="1628800"/>
            <a:ext cx="8496000" cy="350080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7322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691680" y="213285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9045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91680" y="273749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1653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691680" y="336731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3512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691680" y="399633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1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7395170" y="4889700"/>
            <a:ext cx="90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524328" y="4851600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976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4735066" y="4889700"/>
            <a:ext cx="216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436096" y="484626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975</a:t>
            </a:r>
            <a:endParaRPr lang="en-GB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691680" y="4365104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153773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</a:t>
            </a:r>
            <a:endParaRPr lang="en-GB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25" r="1328" b="10000"/>
          <a:stretch/>
        </p:blipFill>
        <p:spPr bwMode="auto">
          <a:xfrm>
            <a:off x="324000" y="1628800"/>
            <a:ext cx="8496000" cy="389484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172" t="62281" r="6831" b="19850"/>
          <a:stretch/>
        </p:blipFill>
        <p:spPr bwMode="auto">
          <a:xfrm>
            <a:off x="6709645" y="4062201"/>
            <a:ext cx="886691" cy="900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" name="Straight Arrow Connector 5"/>
          <p:cNvCxnSpPr/>
          <p:nvPr/>
        </p:nvCxnSpPr>
        <p:spPr>
          <a:xfrm>
            <a:off x="3779912" y="5206053"/>
            <a:ext cx="320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716016" y="514790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432</a:t>
            </a:r>
            <a:endParaRPr lang="en-GB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1970187" y="5205820"/>
            <a:ext cx="176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555776" y="514766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431</a:t>
            </a:r>
            <a:endParaRPr lang="en-GB" dirty="0"/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7190931" y="5205820"/>
            <a:ext cx="147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7308304" y="5147900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433</a:t>
            </a:r>
            <a:endParaRPr lang="en-GB" dirty="0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4884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691680" y="208942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100000</a:t>
            </a:r>
            <a:endParaRPr lang="en-GB" sz="1400" dirty="0"/>
          </a:p>
        </p:txBody>
      </p:sp>
      <p:pic>
        <p:nvPicPr>
          <p:cNvPr id="2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7140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1691680" y="269939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100000</a:t>
            </a:r>
            <a:endParaRPr lang="en-GB" sz="1400" dirty="0"/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0461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1691680" y="333260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100000</a:t>
            </a:r>
            <a:endParaRPr lang="en-GB" sz="1400" dirty="0"/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2192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691680" y="396582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100</a:t>
            </a:r>
            <a:endParaRPr lang="en-GB" sz="1400" dirty="0"/>
          </a:p>
        </p:txBody>
      </p:sp>
      <p:pic>
        <p:nvPicPr>
          <p:cNvPr id="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46" t="64305" r="72699" b="21328"/>
          <a:stretch/>
        </p:blipFill>
        <p:spPr bwMode="auto">
          <a:xfrm>
            <a:off x="3311866" y="4162469"/>
            <a:ext cx="851138" cy="7240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92" t="64305" r="52554" b="21328"/>
          <a:stretch/>
        </p:blipFill>
        <p:spPr bwMode="auto">
          <a:xfrm>
            <a:off x="6260801" y="4162469"/>
            <a:ext cx="988127" cy="7240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23" t="65975" r="72699" b="21328"/>
          <a:stretch/>
        </p:blipFill>
        <p:spPr bwMode="auto">
          <a:xfrm>
            <a:off x="1807121" y="4256124"/>
            <a:ext cx="425569" cy="639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9" name="Straight Connector 28"/>
          <p:cNvCxnSpPr/>
          <p:nvPr/>
        </p:nvCxnSpPr>
        <p:spPr>
          <a:xfrm>
            <a:off x="1731517" y="4538715"/>
            <a:ext cx="70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4998185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29 and Peak 30</a:t>
            </a:r>
            <a:endParaRPr lang="en-GB" dirty="0"/>
          </a:p>
        </p:txBody>
      </p:sp>
      <p:pic>
        <p:nvPicPr>
          <p:cNvPr id="2560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63" r="1470" b="17625"/>
          <a:stretch/>
        </p:blipFill>
        <p:spPr bwMode="auto">
          <a:xfrm>
            <a:off x="324000" y="1628800"/>
            <a:ext cx="8496000" cy="35197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06" t="63368" r="73605" b="27415"/>
          <a:stretch/>
        </p:blipFill>
        <p:spPr bwMode="auto">
          <a:xfrm>
            <a:off x="5707832" y="4127821"/>
            <a:ext cx="740593" cy="49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00" t="63368" r="73605" b="30420"/>
          <a:stretch/>
        </p:blipFill>
        <p:spPr bwMode="auto">
          <a:xfrm>
            <a:off x="1898179" y="4120505"/>
            <a:ext cx="370297" cy="334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9227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91680" y="215190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5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80950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691680" y="275654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3558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691680" y="338636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5417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691680" y="401538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1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6597749" y="4908750"/>
            <a:ext cx="205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1979712" y="4908750"/>
            <a:ext cx="399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851920" y="486531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996</a:t>
            </a:r>
            <a:endParaRPr lang="en-GB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691680" y="4384154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7164288" y="4869160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399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0481399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1</a:t>
            </a:r>
            <a:endParaRPr lang="en-GB" dirty="0"/>
          </a:p>
        </p:txBody>
      </p:sp>
      <p:pic>
        <p:nvPicPr>
          <p:cNvPr id="2662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48" r="1865" b="17887"/>
          <a:stretch/>
        </p:blipFill>
        <p:spPr bwMode="auto">
          <a:xfrm>
            <a:off x="324000" y="1772816"/>
            <a:ext cx="8496000" cy="34989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44429" y="230657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10730" y="226620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5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9305" y="292380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10730" y="287084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9305" y="354988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10730" y="350066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9305" y="4168479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10730" y="412968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1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589637" y="5004000"/>
            <a:ext cx="255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2340056" y="5004000"/>
            <a:ext cx="273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419872" y="494151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007</a:t>
            </a:r>
            <a:endParaRPr lang="en-GB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701205" y="4509120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6208762" y="5003651"/>
            <a:ext cx="255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444208" y="494116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008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8100392" y="494116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00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0355870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2</a:t>
            </a:r>
            <a:endParaRPr lang="en-GB" dirty="0"/>
          </a:p>
        </p:txBody>
      </p:sp>
      <p:pic>
        <p:nvPicPr>
          <p:cNvPr id="2765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97" r="1728" b="17399"/>
          <a:stretch/>
        </p:blipFill>
        <p:spPr bwMode="auto">
          <a:xfrm>
            <a:off x="324000" y="1772816"/>
            <a:ext cx="8496000" cy="353942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44429" y="233084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10730" y="229999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9305" y="294807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10730" y="290463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9305" y="357414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10730" y="353445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9305" y="4202271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10730" y="416347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1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868144" y="5037792"/>
            <a:ext cx="270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1980016" y="5037792"/>
            <a:ext cx="241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843808" y="4975309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063</a:t>
            </a:r>
            <a:endParaRPr lang="en-GB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701205" y="4542912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948264" y="4974960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06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3290260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3</a:t>
            </a:r>
            <a:endParaRPr lang="en-GB" dirty="0"/>
          </a:p>
        </p:txBody>
      </p:sp>
      <p:pic>
        <p:nvPicPr>
          <p:cNvPr id="2867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29" r="1253" b="17873"/>
          <a:stretch/>
        </p:blipFill>
        <p:spPr bwMode="auto">
          <a:xfrm>
            <a:off x="324000" y="1990725"/>
            <a:ext cx="8496000" cy="34898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76" t="63637" r="76310" b="26975"/>
          <a:stretch/>
        </p:blipFill>
        <p:spPr bwMode="auto">
          <a:xfrm>
            <a:off x="6923112" y="4489301"/>
            <a:ext cx="457200" cy="504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08" t="64016" r="75535" b="26596"/>
          <a:stretch/>
        </p:blipFill>
        <p:spPr bwMode="auto">
          <a:xfrm>
            <a:off x="1992288" y="4498826"/>
            <a:ext cx="228600" cy="504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52373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49289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14096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09753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76704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72735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395169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01205" y="435637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15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7812456" y="5230690"/>
            <a:ext cx="86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2160000" y="5230690"/>
            <a:ext cx="504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499992" y="516820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206</a:t>
            </a:r>
            <a:endParaRPr lang="en-GB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691680" y="4975076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7956376" y="516785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20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214604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4</a:t>
            </a:r>
            <a:endParaRPr lang="en-GB" dirty="0"/>
          </a:p>
        </p:txBody>
      </p:sp>
      <p:pic>
        <p:nvPicPr>
          <p:cNvPr id="2969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02" r="1359" b="17614"/>
          <a:stretch/>
        </p:blipFill>
        <p:spPr bwMode="auto">
          <a:xfrm>
            <a:off x="324000" y="1600200"/>
            <a:ext cx="8496000" cy="351437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5417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212333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7140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72797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39748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35778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25604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98680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15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383138" y="4861125"/>
            <a:ext cx="32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3491880" y="4861125"/>
            <a:ext cx="122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851920" y="479864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298</a:t>
            </a:r>
            <a:endParaRPr lang="en-GB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691680" y="4586461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444208" y="480667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29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8912904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5</a:t>
            </a:r>
            <a:endParaRPr lang="en-GB" dirty="0"/>
          </a:p>
        </p:txBody>
      </p:sp>
      <p:pic>
        <p:nvPicPr>
          <p:cNvPr id="3072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35" r="1348" b="18462"/>
          <a:stretch/>
        </p:blipFill>
        <p:spPr bwMode="auto">
          <a:xfrm>
            <a:off x="324000" y="1628800"/>
            <a:ext cx="8496000" cy="346654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96" t="62967" r="67043" b="27748"/>
          <a:stretch/>
        </p:blipFill>
        <p:spPr bwMode="auto">
          <a:xfrm>
            <a:off x="5492849" y="4096122"/>
            <a:ext cx="1133475" cy="499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07" t="62967" r="67043" b="27748"/>
          <a:stretch/>
        </p:blipFill>
        <p:spPr bwMode="auto">
          <a:xfrm>
            <a:off x="2123728" y="4096122"/>
            <a:ext cx="719138" cy="499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8274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15190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9997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275654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3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2605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38636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3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54179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01205" y="401538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5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6156176" y="4889700"/>
            <a:ext cx="262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2267880" y="4889700"/>
            <a:ext cx="367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851920" y="482721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294</a:t>
            </a:r>
            <a:endParaRPr lang="en-GB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691680" y="4567411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444208" y="483525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29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93176685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6</a:t>
            </a:r>
            <a:endParaRPr lang="en-GB" dirty="0"/>
          </a:p>
        </p:txBody>
      </p:sp>
      <p:pic>
        <p:nvPicPr>
          <p:cNvPr id="3174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66" r="1604" b="17796"/>
          <a:stretch/>
        </p:blipFill>
        <p:spPr bwMode="auto">
          <a:xfrm>
            <a:off x="324000" y="1556792"/>
            <a:ext cx="8496000" cy="350983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78" t="61743" r="68452" b="26608"/>
          <a:stretch/>
        </p:blipFill>
        <p:spPr bwMode="auto">
          <a:xfrm>
            <a:off x="5764882" y="3962003"/>
            <a:ext cx="895350" cy="628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810" t="62625" r="22893" b="27585"/>
          <a:stretch/>
        </p:blipFill>
        <p:spPr bwMode="auto">
          <a:xfrm>
            <a:off x="7945685" y="4005205"/>
            <a:ext cx="802779" cy="5282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89" t="62449" r="58303" b="27673"/>
          <a:stretch/>
        </p:blipFill>
        <p:spPr bwMode="auto">
          <a:xfrm>
            <a:off x="2195736" y="4005064"/>
            <a:ext cx="838200" cy="5330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0678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01205" y="207593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3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2401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1205" y="268057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3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35008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01205" y="331039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3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978212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01205" y="393941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 </a:t>
            </a:r>
            <a:r>
              <a:rPr lang="en-GB" sz="1400" dirty="0" smtClean="0"/>
              <a:t>-50</a:t>
            </a:r>
            <a:endParaRPr lang="en-GB" sz="1400" dirty="0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6581047" y="4813733"/>
            <a:ext cx="190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2340160" y="4813733"/>
            <a:ext cx="370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851920" y="4751250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501</a:t>
            </a:r>
            <a:endParaRPr lang="en-GB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691680" y="4491444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7236296" y="4759285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50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67509722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7</a:t>
            </a:r>
            <a:endParaRPr lang="en-GB" dirty="0"/>
          </a:p>
        </p:txBody>
      </p:sp>
      <p:pic>
        <p:nvPicPr>
          <p:cNvPr id="3277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91" r="1499" b="17792"/>
          <a:stretch/>
        </p:blipFill>
        <p:spPr bwMode="auto">
          <a:xfrm>
            <a:off x="324000" y="1364187"/>
            <a:ext cx="8496000" cy="35049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191784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188700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53507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49163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16115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12145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789273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75047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 -15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184280" y="4615269"/>
            <a:ext cx="28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1763688" y="4615036"/>
            <a:ext cx="331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843808" y="4562311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633</a:t>
            </a:r>
            <a:endParaRPr lang="en-GB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691680" y="4245355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5551537" y="4619228"/>
            <a:ext cx="3168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004048" y="456207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634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6804248" y="456207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63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15646130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8</a:t>
            </a:r>
            <a:endParaRPr lang="en-GB" dirty="0"/>
          </a:p>
        </p:txBody>
      </p:sp>
      <p:pic>
        <p:nvPicPr>
          <p:cNvPr id="3379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54" r="1320" b="17322"/>
          <a:stretch/>
        </p:blipFill>
        <p:spPr bwMode="auto">
          <a:xfrm>
            <a:off x="324000" y="1556792"/>
            <a:ext cx="8496000" cy="352046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04" t="63376" r="54864" b="26973"/>
          <a:stretch/>
        </p:blipFill>
        <p:spPr bwMode="auto">
          <a:xfrm>
            <a:off x="2988171" y="4043164"/>
            <a:ext cx="2447925" cy="519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09169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701205" y="206084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0892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01205" y="266548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33499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1205" y="329530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963121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01205" y="392432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50</a:t>
            </a:r>
            <a:r>
              <a:rPr lang="en-GB" sz="1400" dirty="0" smtClean="0"/>
              <a:t> -15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3492248" y="4788884"/>
            <a:ext cx="165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211960" y="4736159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639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691680" y="4438253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724480" y="4793076"/>
            <a:ext cx="3024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804248" y="4735926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64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24036253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9 and Peak 40</a:t>
            </a:r>
            <a:endParaRPr lang="en-GB" dirty="0"/>
          </a:p>
        </p:txBody>
      </p:sp>
      <p:pic>
        <p:nvPicPr>
          <p:cNvPr id="3481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64" r="1533" b="17616"/>
          <a:stretch/>
        </p:blipFill>
        <p:spPr bwMode="auto">
          <a:xfrm>
            <a:off x="324000" y="1700808"/>
            <a:ext cx="8496000" cy="352249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26835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223751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88558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84215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51166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47197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130263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410099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/>
              <a:t>1</a:t>
            </a:r>
            <a:r>
              <a:rPr lang="en-GB" sz="1400" dirty="0" smtClean="0"/>
              <a:t>0</a:t>
            </a:r>
            <a:r>
              <a:rPr lang="en-GB" sz="1400" dirty="0" smtClean="0"/>
              <a:t> -1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2680742" y="4965551"/>
            <a:ext cx="82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781325" y="4912826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643</a:t>
            </a:r>
            <a:endParaRPr lang="en-GB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691680" y="4614920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6540935" y="4969743"/>
            <a:ext cx="144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804248" y="4912593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464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033871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3</a:t>
            </a:r>
            <a:endParaRPr lang="en-GB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57" r="1340" b="10139"/>
          <a:stretch/>
        </p:blipFill>
        <p:spPr bwMode="auto">
          <a:xfrm>
            <a:off x="324000" y="1550843"/>
            <a:ext cx="8496000" cy="392920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76" t="63185" r="69569" b="21945"/>
          <a:stretch/>
        </p:blipFill>
        <p:spPr bwMode="auto">
          <a:xfrm>
            <a:off x="4445919" y="4073430"/>
            <a:ext cx="859809" cy="764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76" t="63185" r="77347" b="21994"/>
          <a:stretch/>
        </p:blipFill>
        <p:spPr bwMode="auto">
          <a:xfrm>
            <a:off x="5305728" y="4075932"/>
            <a:ext cx="822117" cy="7617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" name="Straight Connector 6"/>
          <p:cNvCxnSpPr/>
          <p:nvPr/>
        </p:nvCxnSpPr>
        <p:spPr>
          <a:xfrm>
            <a:off x="1726115" y="4507979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2036862" y="5196295"/>
            <a:ext cx="295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972966" y="513814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433</a:t>
            </a:r>
            <a:endParaRPr lang="en-GB" dirty="0"/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5349230" y="5196062"/>
            <a:ext cx="169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724128" y="513814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434</a:t>
            </a:r>
            <a:endParaRPr lang="en-GB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051" y="212531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691680" y="206590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25000</a:t>
            </a:r>
            <a:endParaRPr lang="en-GB" sz="1400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4977" y="274412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691680" y="269911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25000</a:t>
            </a:r>
            <a:endParaRPr lang="en-GB" sz="1400" dirty="0"/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5452" y="335587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701205" y="333845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25000</a:t>
            </a:r>
            <a:endParaRPr lang="en-GB" sz="1400" dirty="0"/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6551" y="398871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1710730" y="403703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-100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80958689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1</a:t>
            </a:r>
            <a:endParaRPr lang="en-GB" dirty="0"/>
          </a:p>
        </p:txBody>
      </p:sp>
      <p:pic>
        <p:nvPicPr>
          <p:cNvPr id="3584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94" r="1499" b="18047"/>
          <a:stretch/>
        </p:blipFill>
        <p:spPr bwMode="auto">
          <a:xfrm>
            <a:off x="324000" y="1628800"/>
            <a:ext cx="8496000" cy="348031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28" t="62095" r="39928" b="27976"/>
          <a:stretch/>
        </p:blipFill>
        <p:spPr bwMode="auto">
          <a:xfrm>
            <a:off x="4248869" y="4038972"/>
            <a:ext cx="3419475" cy="5352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0" t="62095" r="49434" b="27976"/>
          <a:stretch/>
        </p:blipFill>
        <p:spPr bwMode="auto">
          <a:xfrm>
            <a:off x="2159520" y="4033639"/>
            <a:ext cx="1476376" cy="5352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7322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14238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9045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274702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1653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37683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35129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01205" y="400585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30</a:t>
            </a:r>
            <a:r>
              <a:rPr lang="en-GB" sz="1400" dirty="0" smtClean="0"/>
              <a:t> -3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2231832" y="4870417"/>
            <a:ext cx="244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987824" y="481769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84</a:t>
            </a:r>
            <a:endParaRPr lang="en-GB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903625" y="4874609"/>
            <a:ext cx="234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796136" y="4817459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8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12602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2</a:t>
            </a:r>
            <a:endParaRPr lang="en-GB" dirty="0"/>
          </a:p>
        </p:txBody>
      </p:sp>
      <p:pic>
        <p:nvPicPr>
          <p:cNvPr id="3686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21" r="1425" b="18055"/>
          <a:stretch/>
        </p:blipFill>
        <p:spPr bwMode="auto">
          <a:xfrm>
            <a:off x="324000" y="1866900"/>
            <a:ext cx="8496000" cy="34918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968" t="61985" r="22863" b="27303"/>
          <a:stretch/>
        </p:blipFill>
        <p:spPr bwMode="auto">
          <a:xfrm>
            <a:off x="5525839" y="4286250"/>
            <a:ext cx="2600152" cy="5770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85" t="63529" r="74987" b="27303"/>
          <a:stretch/>
        </p:blipFill>
        <p:spPr bwMode="auto">
          <a:xfrm>
            <a:off x="5284837" y="4374629"/>
            <a:ext cx="717798" cy="4938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1" t="63529" r="73683" b="28210"/>
          <a:stretch/>
        </p:blipFill>
        <p:spPr bwMode="auto">
          <a:xfrm>
            <a:off x="1826171" y="4374629"/>
            <a:ext cx="495301" cy="4450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41782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01205" y="238698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03505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1205" y="299161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5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66113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01205" y="362143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5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279728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01205" y="425045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/>
              <a:t>1</a:t>
            </a:r>
            <a:r>
              <a:rPr lang="en-GB" sz="1400" dirty="0" smtClean="0"/>
              <a:t>0</a:t>
            </a:r>
            <a:r>
              <a:rPr lang="en-GB" sz="1400" dirty="0" smtClean="0"/>
              <a:t> -10</a:t>
            </a:r>
            <a:endParaRPr lang="en-GB" sz="1400" dirty="0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1871792" y="5115016"/>
            <a:ext cx="374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419872" y="5062291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358</a:t>
            </a:r>
            <a:endParaRPr lang="en-GB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691680" y="4619228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5949677" y="5119208"/>
            <a:ext cx="144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444208" y="5062058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35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91673774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3</a:t>
            </a:r>
            <a:endParaRPr lang="en-GB" dirty="0"/>
          </a:p>
        </p:txBody>
      </p:sp>
      <p:pic>
        <p:nvPicPr>
          <p:cNvPr id="3789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49" r="1710" b="17411"/>
          <a:stretch/>
        </p:blipFill>
        <p:spPr bwMode="auto">
          <a:xfrm>
            <a:off x="324000" y="1628800"/>
            <a:ext cx="8496000" cy="352990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43" t="62384" r="71351" b="27514"/>
          <a:stretch/>
        </p:blipFill>
        <p:spPr bwMode="auto">
          <a:xfrm>
            <a:off x="4242048" y="4077072"/>
            <a:ext cx="752475" cy="5457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70" t="62384" r="71351" b="27514"/>
          <a:stretch/>
        </p:blipFill>
        <p:spPr bwMode="auto">
          <a:xfrm>
            <a:off x="1990725" y="4067547"/>
            <a:ext cx="525438" cy="5457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7322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14238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9045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274702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1653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37683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35129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01205" y="400585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30</a:t>
            </a:r>
            <a:r>
              <a:rPr lang="en-GB" sz="1400" dirty="0" smtClean="0"/>
              <a:t> -3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1763688" y="4870417"/>
            <a:ext cx="2664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843808" y="481769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360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691680" y="4384154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076056" y="4874609"/>
            <a:ext cx="198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580112" y="4817459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362</a:t>
            </a:r>
            <a:endParaRPr lang="en-GB" dirty="0"/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4735066" y="4878685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499992" y="482572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36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55133661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4</a:t>
            </a:r>
            <a:endParaRPr lang="en-GB" dirty="0"/>
          </a:p>
        </p:txBody>
      </p:sp>
      <p:pic>
        <p:nvPicPr>
          <p:cNvPr id="3891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87" r="1635" b="17764"/>
          <a:stretch/>
        </p:blipFill>
        <p:spPr bwMode="auto">
          <a:xfrm>
            <a:off x="324000" y="1556792"/>
            <a:ext cx="8496000" cy="352768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2559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209475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4282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69939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36890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32921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987504"/>
            <a:ext cx="1438275" cy="115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95823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30</a:t>
            </a:r>
            <a:r>
              <a:rPr lang="en-GB" sz="1400" dirty="0" smtClean="0"/>
              <a:t> -3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2368447" y="4822792"/>
            <a:ext cx="108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627784" y="477006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562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904368" y="4826984"/>
            <a:ext cx="262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876256" y="4769834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563</a:t>
            </a:r>
            <a:endParaRPr lang="en-GB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3563888" y="4831060"/>
            <a:ext cx="151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067944" y="4778102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561</a:t>
            </a:r>
            <a:endParaRPr lang="en-GB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691680" y="4327004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00611484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5</a:t>
            </a:r>
            <a:endParaRPr lang="en-GB" dirty="0"/>
          </a:p>
        </p:txBody>
      </p:sp>
      <p:pic>
        <p:nvPicPr>
          <p:cNvPr id="3993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95" r="1422" b="17668"/>
          <a:stretch/>
        </p:blipFill>
        <p:spPr bwMode="auto">
          <a:xfrm>
            <a:off x="324000" y="1628800"/>
            <a:ext cx="8496000" cy="350864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53" t="62640" r="25243" b="27514"/>
          <a:stretch/>
        </p:blipFill>
        <p:spPr bwMode="auto">
          <a:xfrm>
            <a:off x="3624784" y="4077072"/>
            <a:ext cx="3947592" cy="5303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6998" y="216369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722349" y="213285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9068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01205" y="274725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1676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1205" y="337707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35758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01205" y="400609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/>
              <a:t>1</a:t>
            </a:r>
            <a:r>
              <a:rPr lang="en-GB" sz="1400" dirty="0" smtClean="0"/>
              <a:t>0</a:t>
            </a:r>
            <a:r>
              <a:rPr lang="en-GB" sz="1400" dirty="0" smtClean="0"/>
              <a:t> -10</a:t>
            </a:r>
            <a:endParaRPr lang="en-GB" sz="1400" dirty="0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2627784" y="4878685"/>
            <a:ext cx="1584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059832" y="4817925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764</a:t>
            </a:r>
            <a:endParaRPr lang="en-GB" dirty="0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5843761" y="4874842"/>
            <a:ext cx="90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002635" y="4817692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766</a:t>
            </a:r>
            <a:endParaRPr lang="en-GB" dirty="0"/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4283968" y="4878918"/>
            <a:ext cx="97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499992" y="4825960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765</a:t>
            </a:r>
            <a:endParaRPr lang="en-GB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1691680" y="4374862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62559838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6</a:t>
            </a:r>
            <a:endParaRPr lang="en-GB" dirty="0"/>
          </a:p>
        </p:txBody>
      </p:sp>
      <p:pic>
        <p:nvPicPr>
          <p:cNvPr id="4096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81" r="1449" b="16283"/>
          <a:stretch/>
        </p:blipFill>
        <p:spPr bwMode="auto">
          <a:xfrm>
            <a:off x="324000" y="1819275"/>
            <a:ext cx="8496000" cy="357424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36067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232983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1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97790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93446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60398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56428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1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222974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419330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</a:t>
            </a:r>
            <a:r>
              <a:rPr lang="en-GB" sz="1400" dirty="0" smtClean="0"/>
              <a:t>00</a:t>
            </a:r>
            <a:r>
              <a:rPr lang="en-GB" sz="1400" dirty="0" smtClean="0"/>
              <a:t> -10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069357" y="5147667"/>
            <a:ext cx="2628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923928" y="5067857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114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6120272" y="5143824"/>
            <a:ext cx="2484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948264" y="5067624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116</a:t>
            </a:r>
            <a:endParaRPr lang="en-GB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691680" y="4552553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87809272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7</a:t>
            </a:r>
            <a:endParaRPr lang="en-GB" dirty="0"/>
          </a:p>
        </p:txBody>
      </p:sp>
      <p:pic>
        <p:nvPicPr>
          <p:cNvPr id="4198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88" r="1297" b="17227"/>
          <a:stretch/>
        </p:blipFill>
        <p:spPr bwMode="auto">
          <a:xfrm>
            <a:off x="324000" y="1556792"/>
            <a:ext cx="8496000" cy="351754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08067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204983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2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69790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65447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2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32398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28428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/>
              <a:t>2</a:t>
            </a:r>
            <a:r>
              <a:rPr lang="en-GB" sz="1400" dirty="0" smtClean="0"/>
              <a:t>0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962027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91331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</a:t>
            </a:r>
            <a:r>
              <a:rPr lang="en-GB" sz="1400" dirty="0" smtClean="0"/>
              <a:t>00</a:t>
            </a:r>
            <a:r>
              <a:rPr lang="en-GB" sz="1400" dirty="0" smtClean="0"/>
              <a:t> -30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419872" y="4797152"/>
            <a:ext cx="165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923928" y="478786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258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445621" y="4797152"/>
            <a:ext cx="31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948264" y="4787627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259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691680" y="4418062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41603104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8</a:t>
            </a:r>
            <a:endParaRPr lang="en-GB" dirty="0"/>
          </a:p>
        </p:txBody>
      </p:sp>
      <p:pic>
        <p:nvPicPr>
          <p:cNvPr id="43010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18" r="1646" b="17622"/>
          <a:stretch/>
        </p:blipFill>
        <p:spPr bwMode="auto">
          <a:xfrm>
            <a:off x="324000" y="1412776"/>
            <a:ext cx="8496000" cy="35178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196672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193588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58395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54052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21003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17033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848076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79936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</a:t>
            </a:r>
            <a:r>
              <a:rPr lang="en-GB" sz="1400" dirty="0" smtClean="0"/>
              <a:t>0</a:t>
            </a:r>
            <a:r>
              <a:rPr lang="en-GB" sz="1400" dirty="0" smtClean="0"/>
              <a:t> -1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835696" y="4683201"/>
            <a:ext cx="306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275856" y="463580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658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705078" y="4683201"/>
            <a:ext cx="3024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948264" y="4635576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660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691680" y="4158605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9525802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9</a:t>
            </a:r>
            <a:endParaRPr lang="en-GB" dirty="0"/>
          </a:p>
        </p:txBody>
      </p:sp>
      <p:pic>
        <p:nvPicPr>
          <p:cNvPr id="44034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88" r="1231" b="18387"/>
          <a:stretch/>
        </p:blipFill>
        <p:spPr bwMode="auto">
          <a:xfrm>
            <a:off x="324000" y="1352550"/>
            <a:ext cx="8496000" cy="345815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189052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185968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50775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46432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13383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09413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771876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72316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</a:t>
            </a:r>
            <a:r>
              <a:rPr lang="en-GB" sz="1400" dirty="0" smtClean="0"/>
              <a:t>0</a:t>
            </a:r>
            <a:r>
              <a:rPr lang="en-GB" sz="1400" dirty="0" smtClean="0"/>
              <a:t> -1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835696" y="4607001"/>
            <a:ext cx="3060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275856" y="454055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695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868456" y="4607001"/>
            <a:ext cx="2808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948264" y="4540326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697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691680" y="4082405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354563" y="4609703"/>
            <a:ext cx="39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229597" y="4543261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69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17561173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50</a:t>
            </a:r>
            <a:endParaRPr lang="en-GB" dirty="0"/>
          </a:p>
        </p:txBody>
      </p:sp>
      <p:pic>
        <p:nvPicPr>
          <p:cNvPr id="45058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79" r="1502" b="18297"/>
          <a:stretch/>
        </p:blipFill>
        <p:spPr bwMode="auto">
          <a:xfrm>
            <a:off x="324000" y="1428750"/>
            <a:ext cx="8496000" cy="346768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49" t="62433" r="68750" b="27932"/>
          <a:stretch/>
        </p:blipFill>
        <p:spPr bwMode="auto">
          <a:xfrm>
            <a:off x="5855940" y="3861048"/>
            <a:ext cx="914400" cy="5194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50" t="62433" r="68750" b="27932"/>
          <a:stretch/>
        </p:blipFill>
        <p:spPr bwMode="auto">
          <a:xfrm>
            <a:off x="2123728" y="3861048"/>
            <a:ext cx="457200" cy="5194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195719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190730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58395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251194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21003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14176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829026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01205" y="377078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</a:t>
            </a:r>
            <a:r>
              <a:rPr lang="en-GB" sz="1400" dirty="0" smtClean="0"/>
              <a:t>0</a:t>
            </a:r>
            <a:r>
              <a:rPr lang="en-GB" sz="1400" dirty="0" smtClean="0"/>
              <a:t> -15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2205261" y="4654626"/>
            <a:ext cx="388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851920" y="4588184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735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6550124" y="4654626"/>
            <a:ext cx="219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948264" y="4587951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736</a:t>
            </a:r>
            <a:endParaRPr lang="en-GB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691680" y="4221088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419121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4</a:t>
            </a:r>
            <a:endParaRPr lang="en-GB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88" r="1276" b="17656"/>
          <a:stretch/>
        </p:blipFill>
        <p:spPr bwMode="auto">
          <a:xfrm>
            <a:off x="378173" y="1438274"/>
            <a:ext cx="8387655" cy="34385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25" r="83851" b="10000"/>
          <a:stretch/>
        </p:blipFill>
        <p:spPr bwMode="auto">
          <a:xfrm>
            <a:off x="381150" y="1504976"/>
            <a:ext cx="1368000" cy="33360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98" t="63689" r="38027" b="26983"/>
          <a:stretch/>
        </p:blipFill>
        <p:spPr bwMode="auto">
          <a:xfrm>
            <a:off x="4211960" y="3889623"/>
            <a:ext cx="2631598" cy="4952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10" t="63689" r="67732" b="26983"/>
          <a:stretch/>
        </p:blipFill>
        <p:spPr bwMode="auto">
          <a:xfrm>
            <a:off x="4067944" y="3889623"/>
            <a:ext cx="1262284" cy="4952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39" t="63689" r="67732" b="26983"/>
          <a:stretch/>
        </p:blipFill>
        <p:spPr bwMode="auto">
          <a:xfrm>
            <a:off x="1860079" y="3889623"/>
            <a:ext cx="631142" cy="4952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6" name="Straight Connector 15"/>
          <p:cNvCxnSpPr/>
          <p:nvPr/>
        </p:nvCxnSpPr>
        <p:spPr>
          <a:xfrm>
            <a:off x="1735640" y="4283571"/>
            <a:ext cx="70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1835696" y="4605511"/>
            <a:ext cx="255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6804248" y="4609703"/>
            <a:ext cx="1584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7025671" y="457160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574</a:t>
            </a:r>
            <a:endParaRPr lang="en-GB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4490467" y="4609703"/>
            <a:ext cx="1368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699792" y="457160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571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4788024" y="4571603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572</a:t>
            </a:r>
            <a:endParaRPr lang="en-GB" dirty="0"/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68201" y="194767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1748830" y="188825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0</a:t>
            </a:r>
            <a:endParaRPr lang="en-GB" sz="1400" dirty="0"/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72602" y="256647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748830" y="252147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0</a:t>
            </a:r>
            <a:endParaRPr lang="en-GB" sz="1400" dirty="0"/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72602" y="317822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1758355" y="316081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0</a:t>
            </a:r>
            <a:endParaRPr lang="en-GB" sz="1400" dirty="0"/>
          </a:p>
        </p:txBody>
      </p:sp>
      <p:pic>
        <p:nvPicPr>
          <p:cNvPr id="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64651" y="380154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1767880" y="385939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0 </a:t>
            </a:r>
            <a:r>
              <a:rPr lang="en-GB" sz="1400" dirty="0" smtClean="0"/>
              <a:t>-400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523462506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51</a:t>
            </a:r>
            <a:endParaRPr lang="en-GB" dirty="0"/>
          </a:p>
        </p:txBody>
      </p:sp>
      <p:pic>
        <p:nvPicPr>
          <p:cNvPr id="4608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79" r="1524" b="17310"/>
          <a:stretch/>
        </p:blipFill>
        <p:spPr bwMode="auto">
          <a:xfrm>
            <a:off x="324000" y="1556792"/>
            <a:ext cx="8496000" cy="351088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08216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01205" y="203227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0</a:t>
            </a:r>
            <a:endParaRPr lang="en-GB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0892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63691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33499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326672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953992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89575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</a:t>
            </a:r>
            <a:r>
              <a:rPr lang="en-GB" sz="1400" dirty="0" smtClean="0"/>
              <a:t>0</a:t>
            </a:r>
            <a:r>
              <a:rPr lang="en-GB" sz="1400" dirty="0" smtClean="0"/>
              <a:t> -400</a:t>
            </a:r>
            <a:endParaRPr lang="en-GB" sz="1400" dirty="0"/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3016399" y="4779592"/>
            <a:ext cx="216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851920" y="471315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815</a:t>
            </a: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445621" y="4779592"/>
            <a:ext cx="32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660232" y="4712917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816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1691680" y="4450829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7690607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52</a:t>
            </a:r>
            <a:endParaRPr lang="en-GB" dirty="0"/>
          </a:p>
        </p:txBody>
      </p:sp>
      <p:pic>
        <p:nvPicPr>
          <p:cNvPr id="22531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82" r="1340" b="17998"/>
          <a:stretch/>
        </p:blipFill>
        <p:spPr bwMode="auto">
          <a:xfrm>
            <a:off x="324000" y="1600200"/>
            <a:ext cx="8496000" cy="347797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37825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701205" y="208793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6458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01205" y="269257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390658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01205" y="332238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09652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01205" y="395141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0</a:t>
            </a:r>
            <a:r>
              <a:rPr lang="en-GB" sz="1400" dirty="0" smtClean="0"/>
              <a:t>0</a:t>
            </a:r>
            <a:r>
              <a:rPr lang="en-GB" sz="1400" dirty="0" smtClean="0"/>
              <a:t> -400</a:t>
            </a:r>
            <a:endParaRPr lang="en-GB" sz="1400" dirty="0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5076296" y="4839211"/>
            <a:ext cx="273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911817" y="4772769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817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2032670" y="4835252"/>
            <a:ext cx="291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247281" y="4768577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816</a:t>
            </a:r>
            <a:endParaRPr lang="en-GB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691680" y="4506489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94917584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53</a:t>
            </a:r>
            <a:endParaRPr lang="en-GB" dirty="0"/>
          </a:p>
        </p:txBody>
      </p:sp>
      <p:pic>
        <p:nvPicPr>
          <p:cNvPr id="4710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55" r="1402" b="19040"/>
          <a:stretch/>
        </p:blipFill>
        <p:spPr bwMode="auto">
          <a:xfrm>
            <a:off x="324000" y="1628800"/>
            <a:ext cx="8496000" cy="342002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59" t="63616" r="69050" b="27712"/>
          <a:stretch/>
        </p:blipFill>
        <p:spPr bwMode="auto">
          <a:xfrm>
            <a:off x="3419872" y="4115172"/>
            <a:ext cx="1076326" cy="4670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04" t="63616" r="69050" b="27712"/>
          <a:stretch/>
        </p:blipFill>
        <p:spPr bwMode="auto">
          <a:xfrm>
            <a:off x="2195736" y="4115172"/>
            <a:ext cx="538163" cy="4670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904" y="216777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1205" y="211788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</a:t>
            </a:r>
            <a:r>
              <a:rPr lang="en-GB" sz="1400" dirty="0" smtClean="0"/>
              <a:t>0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279452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1205" y="272252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342060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01205" y="335233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9780" y="4039601"/>
            <a:ext cx="1438275" cy="57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01205" y="398136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1</a:t>
            </a:r>
            <a:r>
              <a:rPr lang="en-GB" sz="1400" dirty="0" smtClean="0"/>
              <a:t>0</a:t>
            </a:r>
            <a:r>
              <a:rPr lang="en-GB" sz="1400" dirty="0" smtClean="0"/>
              <a:t> -10</a:t>
            </a:r>
            <a:endParaRPr lang="en-GB" sz="1400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5436400" y="4869160"/>
            <a:ext cx="2556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516216" y="478366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mtClean="0"/>
              <a:t>6882</a:t>
            </a:r>
            <a:endParaRPr lang="en-GB" dirty="0" smtClean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2285022" y="4865201"/>
            <a:ext cx="169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771800" y="4779476"/>
            <a:ext cx="864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6881</a:t>
            </a:r>
            <a:endParaRPr lang="en-GB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1691680" y="4355463"/>
            <a:ext cx="71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212246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5</a:t>
            </a:r>
            <a:endParaRPr lang="en-GB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61" r="1339" b="16768"/>
          <a:stretch/>
        </p:blipFill>
        <p:spPr bwMode="auto">
          <a:xfrm>
            <a:off x="324000" y="1268760"/>
            <a:ext cx="8496000" cy="353444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34" t="63155" r="51896" b="26724"/>
          <a:stretch/>
        </p:blipFill>
        <p:spPr bwMode="auto">
          <a:xfrm>
            <a:off x="4209281" y="3764657"/>
            <a:ext cx="866775" cy="4953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915816" y="4528403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780</a:t>
            </a:r>
            <a:endParaRPr lang="en-GB" dirty="0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1782738" y="4605511"/>
            <a:ext cx="295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5781278" y="4605511"/>
            <a:ext cx="298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891949" y="4533503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781</a:t>
            </a:r>
            <a:endParaRPr lang="en-GB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25" r="83851" b="10000"/>
          <a:stretch/>
        </p:blipFill>
        <p:spPr bwMode="auto">
          <a:xfrm>
            <a:off x="324000" y="1340768"/>
            <a:ext cx="1386000" cy="337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0101" y="1788800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20255" y="1738908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</a:t>
            </a:r>
            <a:endParaRPr lang="en-GB" sz="1400" dirty="0"/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502" y="240760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720255" y="237212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</a:t>
            </a:r>
            <a:endParaRPr lang="en-GB" sz="1400" dirty="0"/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4502" y="3019354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1729780" y="301146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</a:t>
            </a:r>
            <a:endParaRPr lang="en-GB" sz="1400" dirty="0"/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6076" y="365219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1739305" y="371004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10 -50</a:t>
            </a:r>
            <a:endParaRPr lang="en-GB" sz="1400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1735640" y="4283571"/>
            <a:ext cx="70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710730" y="4168130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66349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6</a:t>
            </a:r>
            <a:endParaRPr lang="en-GB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79" r="1338" b="16355"/>
          <a:stretch/>
        </p:blipFill>
        <p:spPr bwMode="auto">
          <a:xfrm>
            <a:off x="324000" y="1828799"/>
            <a:ext cx="8496000" cy="35717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46" t="64116" r="70950" b="28594"/>
          <a:stretch/>
        </p:blipFill>
        <p:spPr bwMode="auto">
          <a:xfrm>
            <a:off x="4211960" y="4285486"/>
            <a:ext cx="1332000" cy="5055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5434" y="2371057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725588" y="2321165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0</a:t>
            </a:r>
            <a:endParaRPr lang="en-GB" sz="1400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0310" y="298986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25588" y="2954379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30310" y="3601611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35113" y="359372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2358" y="4234455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44638" y="429230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10 -10</a:t>
            </a:r>
            <a:endParaRPr lang="en-GB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2915816" y="5100275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52</a:t>
            </a:r>
            <a:endParaRPr lang="en-GB" dirty="0"/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1763688" y="5157192"/>
            <a:ext cx="295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4797549" y="5153233"/>
            <a:ext cx="64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4759449" y="5100275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54</a:t>
            </a:r>
            <a:endParaRPr lang="en-GB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710730" y="4563452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861105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7</a:t>
            </a:r>
            <a:endParaRPr lang="en-GB" dirty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13" r="1631" b="17411"/>
          <a:stretch/>
        </p:blipFill>
        <p:spPr bwMode="auto">
          <a:xfrm>
            <a:off x="324000" y="1412776"/>
            <a:ext cx="8496000" cy="35182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3" t="63234" r="67137" b="27089"/>
          <a:stretch/>
        </p:blipFill>
        <p:spPr bwMode="auto">
          <a:xfrm>
            <a:off x="4174232" y="3885431"/>
            <a:ext cx="685800" cy="52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09" t="63234" r="66105" b="27089"/>
          <a:stretch/>
        </p:blipFill>
        <p:spPr bwMode="auto">
          <a:xfrm>
            <a:off x="2627784" y="3886944"/>
            <a:ext cx="387462" cy="522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5909" y="1957199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716063" y="1907307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</a:t>
            </a:r>
            <a:endParaRPr lang="en-GB" sz="1400" dirty="0"/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0785" y="257600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716063" y="2540521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</a:t>
            </a:r>
            <a:endParaRPr lang="en-GB" sz="1400" dirty="0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20785" y="3187753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725588" y="3179863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-</a:t>
            </a:r>
            <a:r>
              <a:rPr lang="en-GB" sz="1400" dirty="0" smtClean="0"/>
              <a:t>25000</a:t>
            </a:r>
            <a:endParaRPr lang="en-GB" sz="1400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3820597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735113" y="3878442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10 -10</a:t>
            </a:r>
            <a:endParaRPr lang="en-GB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3203848" y="4634086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78</a:t>
            </a:r>
            <a:endParaRPr lang="en-GB" dirty="0"/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2690267" y="4677519"/>
            <a:ext cx="1872000" cy="0"/>
          </a:xfrm>
          <a:prstGeom prst="straightConnector1">
            <a:avLst/>
          </a:prstGeom>
          <a:ln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5076128" y="4677519"/>
            <a:ext cx="1044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1710730" y="4149080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6192296" y="4677519"/>
            <a:ext cx="2340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076056" y="4634086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79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6804248" y="4634086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80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407486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eak 8</a:t>
            </a:r>
            <a:endParaRPr lang="en-GB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653" r="1471" b="17474"/>
          <a:stretch/>
        </p:blipFill>
        <p:spPr bwMode="auto">
          <a:xfrm>
            <a:off x="324000" y="1340768"/>
            <a:ext cx="8496000" cy="355007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6384" y="1919332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706538" y="186944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253813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1706538" y="2502654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500000</a:t>
            </a:r>
            <a:endParaRPr lang="en-GB" sz="1400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1260" y="3149886"/>
            <a:ext cx="1438275" cy="371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716063" y="3141996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0 </a:t>
            </a:r>
            <a:r>
              <a:rPr lang="en-GB" sz="1400" dirty="0" smtClean="0"/>
              <a:t>-</a:t>
            </a:r>
            <a:r>
              <a:rPr lang="en-GB" sz="1400" dirty="0" smtClean="0"/>
              <a:t>500</a:t>
            </a:r>
            <a:r>
              <a:rPr lang="en-GB" sz="1400" dirty="0" smtClean="0"/>
              <a:t>000</a:t>
            </a:r>
            <a:endParaRPr lang="en-GB" sz="14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0" t="40124" r="40593" b="52513"/>
          <a:stretch/>
        </p:blipFill>
        <p:spPr bwMode="auto">
          <a:xfrm>
            <a:off x="1712833" y="3779515"/>
            <a:ext cx="111634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735113" y="3799260"/>
            <a:ext cx="10884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-</a:t>
            </a:r>
            <a:r>
              <a:rPr lang="en-GB" sz="1400" dirty="0" smtClean="0"/>
              <a:t>100 -300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3491880" y="459621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81</a:t>
            </a:r>
            <a:endParaRPr lang="en-GB" dirty="0"/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2978299" y="4639652"/>
            <a:ext cx="2016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5328200" y="4639652"/>
            <a:ext cx="1980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710730" y="4244563"/>
            <a:ext cx="70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868144" y="4596219"/>
            <a:ext cx="792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8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14670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41</TotalTime>
  <Words>891</Words>
  <Application>Microsoft Office PowerPoint</Application>
  <PresentationFormat>On-screen Show (4:3)</PresentationFormat>
  <Paragraphs>374</Paragraphs>
  <Slides>5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2</vt:i4>
      </vt:variant>
    </vt:vector>
  </HeadingPairs>
  <TitlesOfParts>
    <vt:vector size="53" baseType="lpstr">
      <vt:lpstr>Office Theme</vt:lpstr>
      <vt:lpstr>IGV Peaks</vt:lpstr>
      <vt:lpstr>Peak 1</vt:lpstr>
      <vt:lpstr>Peak 2</vt:lpstr>
      <vt:lpstr>Peak 3</vt:lpstr>
      <vt:lpstr>Peak 4</vt:lpstr>
      <vt:lpstr>Peak 5</vt:lpstr>
      <vt:lpstr>Peak 6</vt:lpstr>
      <vt:lpstr>Peak 7</vt:lpstr>
      <vt:lpstr>Peak 8</vt:lpstr>
      <vt:lpstr>Peak 9</vt:lpstr>
      <vt:lpstr>Peak 10</vt:lpstr>
      <vt:lpstr>Peak 11</vt:lpstr>
      <vt:lpstr>Peak 12</vt:lpstr>
      <vt:lpstr>Peak 13</vt:lpstr>
      <vt:lpstr>Peak 14</vt:lpstr>
      <vt:lpstr>Peak 15</vt:lpstr>
      <vt:lpstr>Peak 16</vt:lpstr>
      <vt:lpstr>Peak 17</vt:lpstr>
      <vt:lpstr>Peak 18 msmeg_2332 and msmeg_2334 not on microarray</vt:lpstr>
      <vt:lpstr>Peak 19</vt:lpstr>
      <vt:lpstr>Peak 20</vt:lpstr>
      <vt:lpstr>Peak 21</vt:lpstr>
      <vt:lpstr>Peak 22</vt:lpstr>
      <vt:lpstr>Peak 23</vt:lpstr>
      <vt:lpstr>Peak 24</vt:lpstr>
      <vt:lpstr>Peak 25</vt:lpstr>
      <vt:lpstr>Peak 26</vt:lpstr>
      <vt:lpstr>Peak 27</vt:lpstr>
      <vt:lpstr>Peak 28</vt:lpstr>
      <vt:lpstr>Peak 29 and Peak 30</vt:lpstr>
      <vt:lpstr>Peak 31</vt:lpstr>
      <vt:lpstr>Peak 32</vt:lpstr>
      <vt:lpstr>Peak 33</vt:lpstr>
      <vt:lpstr>Peak 34</vt:lpstr>
      <vt:lpstr>Peak 35</vt:lpstr>
      <vt:lpstr>Peak 36</vt:lpstr>
      <vt:lpstr>Peak 37</vt:lpstr>
      <vt:lpstr>Peak 38</vt:lpstr>
      <vt:lpstr>Peak 39 and Peak 40</vt:lpstr>
      <vt:lpstr>Peak 41</vt:lpstr>
      <vt:lpstr>Peak 42</vt:lpstr>
      <vt:lpstr>Peak 43</vt:lpstr>
      <vt:lpstr>Peak 44</vt:lpstr>
      <vt:lpstr>Peak 45</vt:lpstr>
      <vt:lpstr>Peak 46</vt:lpstr>
      <vt:lpstr>Peak 47</vt:lpstr>
      <vt:lpstr>Peak 48</vt:lpstr>
      <vt:lpstr>Peak 49</vt:lpstr>
      <vt:lpstr>Peak 50</vt:lpstr>
      <vt:lpstr>Peak 51</vt:lpstr>
      <vt:lpstr>Peak 52</vt:lpstr>
      <vt:lpstr>Peak 53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ctoria</dc:creator>
  <cp:lastModifiedBy>Victoria</cp:lastModifiedBy>
  <cp:revision>42</cp:revision>
  <dcterms:created xsi:type="dcterms:W3CDTF">2012-11-29T21:38:22Z</dcterms:created>
  <dcterms:modified xsi:type="dcterms:W3CDTF">2012-12-09T23:16:39Z</dcterms:modified>
</cp:coreProperties>
</file>